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media/image9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F235B8-4A71-4CF0-BF02-C450741C5FC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B29F32-BBF3-4D8A-8E53-F1136A2A63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F3B1EF-3720-487F-BE16-440FCA7522E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2E5409-7EE0-476A-8C96-1CB3D3EB639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EB5E21-2C19-4DF4-91EC-D1B2529159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E700F3-DF85-4B05-A1F5-9254B61C37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E34377-4EE9-415E-B2FD-2519EAE3EB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C5C496-7A96-483B-BC02-2C46D98B3F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B2DD00-17CF-46EB-BC70-2D0ACED8A1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818F11-70FD-40CD-ADF5-56E0A05D62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79D427-EF36-4CAD-857D-DE002D1D61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015C74-2CDE-4679-98EC-1E9EA08D18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486DD6-B3AA-47C5-BEA3-B5D1899C84A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http://www.jmir.org/2003/2" TargetMode="External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8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600200" y="1447920"/>
            <a:ext cx="6035760" cy="366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ultimedia appendix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evelopment and Evaluation of the Virtual Pathology Slide: A New Tool in Telepatholog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J Med Internet Res 200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Vol. 5 / Iss. 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 u="sng">
                <a:solidFill>
                  <a:srgbClr val="009999"/>
                </a:solidFill>
                <a:uFillTx/>
                <a:latin typeface="Arial"/>
                <a:hlinkClick r:id="rId1"/>
              </a:rPr>
              <a:t>http://www.jmir.org/2003/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ese slides show the ten breast needle core biopsies presented to 17 pathologists or trainee pathologists using the VPS for evaluation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797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27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296280" cy="6878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27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296280" cy="6910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27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27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27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797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3-06-09T20:13:54Z</dcterms:created>
  <dc:creator>Gunther Eysenbach</dc:creator>
  <dc:description/>
  <dc:language>en-US</dc:language>
  <cp:lastModifiedBy>Gunther Eysenbach</cp:lastModifiedBy>
  <dcterms:modified xsi:type="dcterms:W3CDTF">2003-06-09T20:21:08Z</dcterms:modified>
  <cp:revision>2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r8>-182653882</vt:r8>
  </property>
  <property fmtid="{D5CDD505-2E9C-101B-9397-08002B2CF9AE}" pid="3" name="_AuthorEmail">
    <vt:lpwstr>geysenba@uhnres.utoronto.ca</vt:lpwstr>
  </property>
  <property fmtid="{D5CDD505-2E9C-101B-9397-08002B2CF9AE}" pid="4" name="_AuthorEmailDisplayName">
    <vt:lpwstr>Dr. Gunther Eysenbach</vt:lpwstr>
  </property>
  <property fmtid="{D5CDD505-2E9C-101B-9397-08002B2CF9AE}" pid="5" name="_EmailSubject">
    <vt:lpwstr>2003031001</vt:lpwstr>
  </property>
</Properties>
</file>